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7" d="100"/>
          <a:sy n="97" d="100"/>
        </p:scale>
        <p:origin x="103" y="4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AA2B7C-7BE3-4D80-9755-664772F410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6B0A0A7-318F-4201-86D0-7CF91D8D939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E9AB65-70B9-49B8-9D03-436723A3EA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865E2-2EBE-4680-8EB0-B9DB5304AA00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E9C837-B217-4D0E-9566-ECA6C4A630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C75948-0307-4F44-84BD-8A41B8466D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FBA80-81F1-4EAA-B535-E85DBB474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6227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8B4980-4E6D-4115-B124-4A1C68EA08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6ED39A4-E660-4400-A8C4-5DD1F8081E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D82435-9994-4617-B859-9E56C1833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865E2-2EBE-4680-8EB0-B9DB5304AA00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4E1865-EFF3-4F1C-B924-93F486C43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519DA3-7E96-4852-85DC-2633267836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FBA80-81F1-4EAA-B535-E85DBB474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4877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F4C852A-0F5C-403D-B171-D5B0C8AD076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E21CFAB-43EB-4591-82B2-C12407AD59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D8A9AB-6BF5-4C51-8E3C-7A0A227B0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865E2-2EBE-4680-8EB0-B9DB5304AA00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70D976-84AE-40B2-9877-F476F9AB9A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245F36-1AD4-4FF8-A543-A85DCDB9A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FBA80-81F1-4EAA-B535-E85DBB474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8104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138AC5-3F89-4EAA-A5C8-81CFF57013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980EE2-2179-4AAB-8D11-F9EB9470B3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BCFAAD-0CBC-441A-86CB-954B4A3CF4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865E2-2EBE-4680-8EB0-B9DB5304AA00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7A06AD-FA83-4298-8920-C088ED49CB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A43762-ACA5-48EA-B0E6-9433363513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FBA80-81F1-4EAA-B535-E85DBB474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3407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FE35C0-5581-46D7-92DC-B6F1CC0B4E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171B3E-E0F3-41B6-82B0-C3F513B133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40BA86-6EAD-49E0-8841-19395F1030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865E2-2EBE-4680-8EB0-B9DB5304AA00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DBBAD5-D231-4DA7-9168-48725C9793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798509-B11A-4881-AEBD-03ECDDA863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FBA80-81F1-4EAA-B535-E85DBB474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47661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6AF9DE-B0B0-42A3-BD9C-D1DC3AE40C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5990FE-3A6E-4003-863D-AA9BBBC5C6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85F6344-1279-4EA7-BBCD-E77C30CCE7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FAECA5-9AA2-46B2-BD22-1646CE8348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865E2-2EBE-4680-8EB0-B9DB5304AA00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E8C918-8610-47C8-8F4B-7CCCE1E423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5675C6-1217-4AB3-AFCB-F5AE588DE5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FBA80-81F1-4EAA-B535-E85DBB474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1818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238588-4150-4E26-A712-C3335494EA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AA2194-419A-46DE-A506-C53BB784EC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2B6A765-4274-4B2C-8156-ED19DB0231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DECD647-78D0-4D2F-80FF-5D719819F4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1BB4C84-A91E-41CA-85E9-2892BBE18A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D455868-D24E-4A6D-A1E9-09997E1FC5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865E2-2EBE-4680-8EB0-B9DB5304AA00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B886EA6-BDD9-4164-8FE9-ABD08DFD5D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D9C28D9-571D-4F5E-9131-49DC930D5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FBA80-81F1-4EAA-B535-E85DBB474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05289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FC47BA-1749-49FF-BE57-5442908ABD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9F46381-1CC1-45AE-91D2-60FDC37246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865E2-2EBE-4680-8EB0-B9DB5304AA00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860EDC8-D39C-4FA2-92D4-3373B12D91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1C812E9-4DA3-4336-98B1-1B2D1B39C3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FBA80-81F1-4EAA-B535-E85DBB474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80293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6A41D1A-C5C3-4D80-9BF4-4F7E55C1F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865E2-2EBE-4680-8EB0-B9DB5304AA00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4CA9DF8-A26F-435C-93C8-E4CD64FA0A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DDA6A1-1E2D-4A46-A39B-986897D4CA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FBA80-81F1-4EAA-B535-E85DBB474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3583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5D931A-385F-48DE-BC1E-7357F0B9A4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53858E-C56F-4EED-A6B5-DFF15260B9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E9C23A-678E-4737-8BF3-C49E981BED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316C50-DA1F-413B-A041-88C62200A1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865E2-2EBE-4680-8EB0-B9DB5304AA00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52FEBA-B16A-4B19-97FC-182B5B0B70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F6F94D-60DE-41B3-9DD7-DD8F81E301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FBA80-81F1-4EAA-B535-E85DBB474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408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8E5F62-ECD5-44FF-9DD9-74350C456B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A4A11C6-1F08-4806-A1B3-603D410FC9D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8DBF04-0ACB-4547-80B8-5587B88F14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647915-A9CE-49CC-A6F9-B3FD03FEE5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8865E2-2EBE-4680-8EB0-B9DB5304AA00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769343-299C-45BD-9261-183A5DA05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E4D9D1-4EC1-43BE-A799-5A3B40CF6B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FBA80-81F1-4EAA-B535-E85DBB474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7180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72C85DF-B81D-4AFD-8CD5-76E8738674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D36CB8-C5C7-433B-9BB1-4FCCB30074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F43F8B-1BAA-499D-B591-A17665A7454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8865E2-2EBE-4680-8EB0-B9DB5304AA00}" type="datetimeFigureOut">
              <a:rPr lang="en-GB" smtClean="0"/>
              <a:t>31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C7B3A5-DCA8-48B5-95F0-F8A50AFE41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18B221-442B-4C90-A82D-3D5F0089A0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2FBA80-81F1-4EAA-B535-E85DBB474A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1982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B551046B-04BA-E640-CFBE-265A7E5AEEE9}"/>
              </a:ext>
            </a:extLst>
          </p:cNvPr>
          <p:cNvGrpSpPr/>
          <p:nvPr/>
        </p:nvGrpSpPr>
        <p:grpSpPr>
          <a:xfrm>
            <a:off x="747712" y="228600"/>
            <a:ext cx="10312159" cy="4919662"/>
            <a:chOff x="7065" y="0"/>
            <a:chExt cx="12167232" cy="6858000"/>
          </a:xfrm>
        </p:grpSpPr>
        <p:pic>
          <p:nvPicPr>
            <p:cNvPr id="13" name="Picture 12" descr="Graphical user interface, application, table, Excel&#10;&#10;Description automatically generated">
              <a:extLst>
                <a:ext uri="{FF2B5EF4-FFF2-40B4-BE49-F238E27FC236}">
                  <a16:creationId xmlns:a16="http://schemas.microsoft.com/office/drawing/2014/main" id="{B67484F3-2C3C-85A8-4DD6-1E7191BA731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156270" y="0"/>
              <a:ext cx="6018027" cy="6858000"/>
            </a:xfrm>
            <a:prstGeom prst="rect">
              <a:avLst/>
            </a:prstGeom>
          </p:spPr>
        </p:pic>
        <p:pic>
          <p:nvPicPr>
            <p:cNvPr id="12" name="Picture 11" descr="Graphical user interface, application, table, PowerPoint&#10;&#10;Description automatically generated">
              <a:extLst>
                <a:ext uri="{FF2B5EF4-FFF2-40B4-BE49-F238E27FC236}">
                  <a16:creationId xmlns:a16="http://schemas.microsoft.com/office/drawing/2014/main" id="{0B84BA6B-5210-0359-9610-DC91F3190BE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065" y="0"/>
              <a:ext cx="6018026" cy="6858000"/>
            </a:xfrm>
            <a:prstGeom prst="rect">
              <a:avLst/>
            </a:prstGeom>
          </p:spPr>
        </p:pic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715F654E-05E5-ED04-E387-192776DE8ADD}"/>
              </a:ext>
            </a:extLst>
          </p:cNvPr>
          <p:cNvSpPr txBox="1"/>
          <p:nvPr/>
        </p:nvSpPr>
        <p:spPr>
          <a:xfrm>
            <a:off x="847725" y="5453063"/>
            <a:ext cx="102121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.</a:t>
            </a:r>
            <a:r>
              <a:rPr lang="en-US" dirty="0"/>
              <a:t> Pre- and post-vaccination homologous and heterologous log10 VN </a:t>
            </a:r>
            <a:r>
              <a:rPr lang="en-US" dirty="0" err="1"/>
              <a:t>titres</a:t>
            </a:r>
            <a:r>
              <a:rPr lang="en-US" dirty="0"/>
              <a:t> of calves in different age groups. Animal numbers with suffix “B” received a second vaccination 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64461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Paton</dc:creator>
  <cp:lastModifiedBy>David Paton</cp:lastModifiedBy>
  <cp:revision>52</cp:revision>
  <dcterms:created xsi:type="dcterms:W3CDTF">2022-01-01T20:10:44Z</dcterms:created>
  <dcterms:modified xsi:type="dcterms:W3CDTF">2023-10-31T09:32:11Z</dcterms:modified>
</cp:coreProperties>
</file>